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11" r:id="rId2"/>
  </p:sldIdLst>
  <p:sldSz cx="6858000" cy="9144000" type="screen4x3"/>
  <p:notesSz cx="9926638" cy="6797675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1C4EB"/>
    <a:srgbClr val="00EBE6"/>
    <a:srgbClr val="FF7C80"/>
    <a:srgbClr val="00FFFF"/>
    <a:srgbClr val="00CC99"/>
    <a:srgbClr val="1919FF"/>
    <a:srgbClr val="FF00FF"/>
    <a:srgbClr val="00FF00"/>
    <a:srgbClr val="3399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6399" autoAdjust="0"/>
  </p:normalViewPr>
  <p:slideViewPr>
    <p:cSldViewPr>
      <p:cViewPr varScale="1">
        <p:scale>
          <a:sx n="80" d="100"/>
          <a:sy n="80" d="100"/>
        </p:scale>
        <p:origin x="-2598" y="-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50" d="100"/>
        <a:sy n="150" d="100"/>
      </p:scale>
      <p:origin x="0" y="2154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302625" cy="34026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quarter" idx="1"/>
          </p:nvPr>
        </p:nvSpPr>
        <p:spPr>
          <a:xfrm>
            <a:off x="5621696" y="0"/>
            <a:ext cx="4302625" cy="34026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968DD1-5FC8-4FE3-BDF7-2BACEF92AB9B}" type="datetimeFigureOut">
              <a:rPr lang="fr-FR" smtClean="0"/>
              <a:t>11/07/201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2"/>
          </p:nvPr>
        </p:nvSpPr>
        <p:spPr>
          <a:xfrm>
            <a:off x="0" y="6456324"/>
            <a:ext cx="4302625" cy="34026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3"/>
          </p:nvPr>
        </p:nvSpPr>
        <p:spPr>
          <a:xfrm>
            <a:off x="5621696" y="6456324"/>
            <a:ext cx="4302625" cy="34026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2BC3CF0-5940-485A-B765-000BF9CF04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9949489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301543" cy="33988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5622799" y="0"/>
            <a:ext cx="4301543" cy="33988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572D7E6-D5FF-44A8-97C1-2338DD8F19DF}" type="datetimeFigureOut">
              <a:rPr lang="fr-FR" smtClean="0"/>
              <a:t>11/07/2014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4006850" y="509588"/>
            <a:ext cx="1912938" cy="25495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992665" y="3228896"/>
            <a:ext cx="7941310" cy="305895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1" y="6456611"/>
            <a:ext cx="4301543" cy="33988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5622799" y="6456611"/>
            <a:ext cx="4301543" cy="33988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630C0A6-D5F3-47A2-AD55-7E957E56645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54602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04A3B-4096-4A12-AC14-6B0EA9C86481}" type="datetimeFigureOut">
              <a:rPr lang="fr-FR" smtClean="0"/>
              <a:t>11/07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BE200-6851-47FF-ADC8-1E9BC6973A4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779358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04A3B-4096-4A12-AC14-6B0EA9C86481}" type="datetimeFigureOut">
              <a:rPr lang="fr-FR" smtClean="0"/>
              <a:t>11/07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BE200-6851-47FF-ADC8-1E9BC6973A4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43204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04A3B-4096-4A12-AC14-6B0EA9C86481}" type="datetimeFigureOut">
              <a:rPr lang="fr-FR" smtClean="0"/>
              <a:t>11/07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BE200-6851-47FF-ADC8-1E9BC6973A4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809562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04A3B-4096-4A12-AC14-6B0EA9C86481}" type="datetimeFigureOut">
              <a:rPr lang="fr-FR" smtClean="0"/>
              <a:t>11/07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BE200-6851-47FF-ADC8-1E9BC6973A4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78936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04A3B-4096-4A12-AC14-6B0EA9C86481}" type="datetimeFigureOut">
              <a:rPr lang="fr-FR" smtClean="0"/>
              <a:t>11/07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BE200-6851-47FF-ADC8-1E9BC6973A4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244904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04A3B-4096-4A12-AC14-6B0EA9C86481}" type="datetimeFigureOut">
              <a:rPr lang="fr-FR" smtClean="0"/>
              <a:t>11/07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BE200-6851-47FF-ADC8-1E9BC6973A4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208352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04A3B-4096-4A12-AC14-6B0EA9C86481}" type="datetimeFigureOut">
              <a:rPr lang="fr-FR" smtClean="0"/>
              <a:t>11/07/2014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BE200-6851-47FF-ADC8-1E9BC6973A4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920044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04A3B-4096-4A12-AC14-6B0EA9C86481}" type="datetimeFigureOut">
              <a:rPr lang="fr-FR" smtClean="0"/>
              <a:t>11/07/201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BE200-6851-47FF-ADC8-1E9BC6973A4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264973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04A3B-4096-4A12-AC14-6B0EA9C86481}" type="datetimeFigureOut">
              <a:rPr lang="fr-FR" smtClean="0"/>
              <a:t>11/07/2014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BE200-6851-47FF-ADC8-1E9BC6973A4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651228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04A3B-4096-4A12-AC14-6B0EA9C86481}" type="datetimeFigureOut">
              <a:rPr lang="fr-FR" smtClean="0"/>
              <a:t>11/07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BE200-6851-47FF-ADC8-1E9BC6973A4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528040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04A3B-4096-4A12-AC14-6B0EA9C86481}" type="datetimeFigureOut">
              <a:rPr lang="fr-FR" smtClean="0"/>
              <a:t>11/07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BE200-6851-47FF-ADC8-1E9BC6973A4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305747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804A3B-4096-4A12-AC14-6B0EA9C86481}" type="datetimeFigureOut">
              <a:rPr lang="fr-FR" smtClean="0"/>
              <a:t>11/07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7BE200-6851-47FF-ADC8-1E9BC6973A4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15684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au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38531704"/>
              </p:ext>
            </p:extLst>
          </p:nvPr>
        </p:nvGraphicFramePr>
        <p:xfrm>
          <a:off x="332656" y="827584"/>
          <a:ext cx="5897880" cy="2865120"/>
        </p:xfrm>
        <a:graphic>
          <a:graphicData uri="http://schemas.openxmlformats.org/drawingml/2006/table">
            <a:tbl>
              <a:tblPr firstRow="1" firstCol="1" lastRow="1" lastCol="1" bandRow="1" bandCol="1">
                <a:tableStyleId>{5C22544A-7EE6-4342-B048-85BDC9FD1C3A}</a:tableStyleId>
              </a:tblPr>
              <a:tblGrid>
                <a:gridCol w="1097280"/>
                <a:gridCol w="2514600"/>
                <a:gridCol w="2286000"/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chemeClr val="tx1"/>
                          </a:solidFill>
                          <a:effectLst/>
                        </a:rPr>
                        <a:t>Primer name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chemeClr val="tx1"/>
                          </a:solidFill>
                          <a:effectLst/>
                        </a:rPr>
                        <a:t>Forward Primer sequence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chemeClr val="tx1"/>
                          </a:solidFill>
                          <a:effectLst/>
                        </a:rPr>
                        <a:t>Reverse Primer sequence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8829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</a:rPr>
                        <a:t>HPRT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>
                          <a:solidFill>
                            <a:schemeClr val="tx1"/>
                          </a:solidFill>
                          <a:effectLst/>
                        </a:rPr>
                        <a:t>AAACCAAAGATGGTCAAGGT</a:t>
                      </a:r>
                      <a:endParaRPr lang="fr-FR" sz="1200" b="1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</a:rPr>
                        <a:t>TCTTAGGCTTTGTATTTTGCTT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</a:tr>
              <a:tr h="28829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</a:rPr>
                        <a:t>b-Actin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>
                          <a:solidFill>
                            <a:schemeClr val="tx1"/>
                          </a:solidFill>
                          <a:effectLst/>
                        </a:rPr>
                        <a:t>CCAACCGTGAGAAGATGACC</a:t>
                      </a:r>
                      <a:endParaRPr lang="fr-FR" sz="1200" b="1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</a:rPr>
                        <a:t>AGTCCATCACGATGCCAGT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</a:tr>
              <a:tr h="28829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</a:rPr>
                        <a:t>GAPDH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>
                          <a:solidFill>
                            <a:schemeClr val="tx1"/>
                          </a:solidFill>
                          <a:effectLst/>
                        </a:rPr>
                        <a:t>GGCGTGAACCACGAGAAGTATAA</a:t>
                      </a:r>
                      <a:endParaRPr lang="fr-FR" sz="1200" b="1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chemeClr val="tx1"/>
                          </a:solidFill>
                          <a:effectLst/>
                        </a:rPr>
                        <a:t>CCCTCCACGATGCCAAAGT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</a:tr>
              <a:tr h="28829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</a:rPr>
                        <a:t>IFN</a:t>
                      </a: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sym typeface="Symbol"/>
                        </a:rPr>
                        <a:t>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>
                          <a:solidFill>
                            <a:schemeClr val="tx1"/>
                          </a:solidFill>
                          <a:effectLst/>
                        </a:rPr>
                        <a:t>TTCCGGTGGATGATCTGC</a:t>
                      </a:r>
                      <a:endParaRPr lang="fr-FR" sz="1200" b="1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</a:rPr>
                        <a:t>GAGAACCATTACATTGATGCTC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</a:tr>
              <a:tr h="28829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</a:rPr>
                        <a:t>IL22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>
                          <a:solidFill>
                            <a:schemeClr val="tx1"/>
                          </a:solidFill>
                          <a:effectLst/>
                        </a:rPr>
                        <a:t>GAAGCGCTGCTACGTGCTGA</a:t>
                      </a:r>
                      <a:endParaRPr lang="fr-FR" sz="1200" b="1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</a:rPr>
                        <a:t>AGCACATTCACGTTTCAGGGTT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</a:tr>
              <a:tr h="28829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</a:rPr>
                        <a:t>NKp46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>
                          <a:solidFill>
                            <a:schemeClr val="tx1"/>
                          </a:solidFill>
                          <a:effectLst/>
                        </a:rPr>
                        <a:t>CCTGTGAAGCTCCTGGTCAAA</a:t>
                      </a:r>
                      <a:endParaRPr lang="fr-FR" sz="1200" b="1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</a:rPr>
                        <a:t>CAGGACAGCCAGGCCAAGC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</a:tr>
              <a:tr h="28829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</a:rPr>
                        <a:t>Crypto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</a:rPr>
                        <a:t>AGAATGGTTAATTGACACCGGTAGTGT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</a:rPr>
                        <a:t>AACGCCGTTTGGTGCCTTACCTTCG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131871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409</TotalTime>
  <Words>30</Words>
  <Application>Microsoft Office PowerPoint</Application>
  <PresentationFormat>Affichage à l'écran (4:3)</PresentationFormat>
  <Paragraphs>25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INR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drouet</dc:creator>
  <cp:lastModifiedBy>fdrouet</cp:lastModifiedBy>
  <cp:revision>373</cp:revision>
  <cp:lastPrinted>2014-07-03T13:42:47Z</cp:lastPrinted>
  <dcterms:created xsi:type="dcterms:W3CDTF">2014-02-14T16:20:24Z</dcterms:created>
  <dcterms:modified xsi:type="dcterms:W3CDTF">2014-07-11T08:14:53Z</dcterms:modified>
</cp:coreProperties>
</file>